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76" r:id="rId1"/>
  </p:sldMasterIdLst>
  <p:sldIdLst>
    <p:sldId id="256" r:id="rId2"/>
  </p:sldIdLst>
  <p:sldSz cx="8172450" cy="6551613"/>
  <p:notesSz cx="6858000" cy="9144000"/>
  <p:defaultTextStyle>
    <a:defPPr>
      <a:defRPr lang="en-US"/>
    </a:defPPr>
    <a:lvl1pPr marL="0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1pPr>
    <a:lvl2pPr marL="404849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2pPr>
    <a:lvl3pPr marL="809699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3pPr>
    <a:lvl4pPr marL="1214549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4pPr>
    <a:lvl5pPr marL="1619398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5pPr>
    <a:lvl6pPr marL="2024246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6pPr>
    <a:lvl7pPr marL="2429095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7pPr>
    <a:lvl8pPr marL="2833945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8pPr>
    <a:lvl9pPr marL="3238794" algn="l" defTabSz="809699" rtl="0" eaLnBrk="1" latinLnBrk="0" hangingPunct="1">
      <a:defRPr sz="159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574" userDrawn="1">
          <p15:clr>
            <a:srgbClr val="A4A3A4"/>
          </p15:clr>
        </p15:guide>
        <p15:guide id="3" orient="horz" pos="20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630" y="114"/>
      </p:cViewPr>
      <p:guideLst>
        <p:guide pos="2574"/>
        <p:guide orient="horz" pos="20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2934" y="1072220"/>
            <a:ext cx="6946583" cy="2280932"/>
          </a:xfrm>
        </p:spPr>
        <p:txBody>
          <a:bodyPr anchor="b"/>
          <a:lstStyle>
            <a:lvl1pPr algn="ctr">
              <a:defRPr sz="536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1556" y="3441114"/>
            <a:ext cx="6129338" cy="1581789"/>
          </a:xfrm>
        </p:spPr>
        <p:txBody>
          <a:bodyPr/>
          <a:lstStyle>
            <a:lvl1pPr marL="0" indent="0" algn="ctr">
              <a:buNone/>
              <a:defRPr sz="2145"/>
            </a:lvl1pPr>
            <a:lvl2pPr marL="408645" indent="0" algn="ctr">
              <a:buNone/>
              <a:defRPr sz="1788"/>
            </a:lvl2pPr>
            <a:lvl3pPr marL="817291" indent="0" algn="ctr">
              <a:buNone/>
              <a:defRPr sz="1609"/>
            </a:lvl3pPr>
            <a:lvl4pPr marL="1225936" indent="0" algn="ctr">
              <a:buNone/>
              <a:defRPr sz="1430"/>
            </a:lvl4pPr>
            <a:lvl5pPr marL="1634581" indent="0" algn="ctr">
              <a:buNone/>
              <a:defRPr sz="1430"/>
            </a:lvl5pPr>
            <a:lvl6pPr marL="2043227" indent="0" algn="ctr">
              <a:buNone/>
              <a:defRPr sz="1430"/>
            </a:lvl6pPr>
            <a:lvl7pPr marL="2451872" indent="0" algn="ctr">
              <a:buNone/>
              <a:defRPr sz="1430"/>
            </a:lvl7pPr>
            <a:lvl8pPr marL="2860518" indent="0" algn="ctr">
              <a:buNone/>
              <a:defRPr sz="1430"/>
            </a:lvl8pPr>
            <a:lvl9pPr marL="3269163" indent="0" algn="ctr">
              <a:buNone/>
              <a:defRPr sz="143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8261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6562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48410" y="348813"/>
            <a:ext cx="1762185" cy="555218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1856" y="348813"/>
            <a:ext cx="5184398" cy="555218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4228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28734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7600" y="1633355"/>
            <a:ext cx="7048738" cy="2725289"/>
          </a:xfrm>
        </p:spPr>
        <p:txBody>
          <a:bodyPr anchor="b"/>
          <a:lstStyle>
            <a:lvl1pPr>
              <a:defRPr sz="536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7600" y="4384426"/>
            <a:ext cx="7048738" cy="1433165"/>
          </a:xfrm>
        </p:spPr>
        <p:txBody>
          <a:bodyPr/>
          <a:lstStyle>
            <a:lvl1pPr marL="0" indent="0">
              <a:buNone/>
              <a:defRPr sz="2145">
                <a:solidFill>
                  <a:schemeClr val="tx1"/>
                </a:solidFill>
              </a:defRPr>
            </a:lvl1pPr>
            <a:lvl2pPr marL="408645" indent="0">
              <a:buNone/>
              <a:defRPr sz="1788">
                <a:solidFill>
                  <a:schemeClr val="tx1">
                    <a:tint val="75000"/>
                  </a:schemeClr>
                </a:solidFill>
              </a:defRPr>
            </a:lvl2pPr>
            <a:lvl3pPr marL="817291" indent="0">
              <a:buNone/>
              <a:defRPr sz="1609">
                <a:solidFill>
                  <a:schemeClr val="tx1">
                    <a:tint val="75000"/>
                  </a:schemeClr>
                </a:solidFill>
              </a:defRPr>
            </a:lvl3pPr>
            <a:lvl4pPr marL="1225936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4pPr>
            <a:lvl5pPr marL="1634581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5pPr>
            <a:lvl6pPr marL="2043227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6pPr>
            <a:lvl7pPr marL="2451872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7pPr>
            <a:lvl8pPr marL="2860518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8pPr>
            <a:lvl9pPr marL="3269163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2422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1856" y="1744064"/>
            <a:ext cx="3473291" cy="41569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37303" y="1744064"/>
            <a:ext cx="3473291" cy="41569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74694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2920" y="348814"/>
            <a:ext cx="7048738" cy="126634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2921" y="1606056"/>
            <a:ext cx="3457329" cy="787103"/>
          </a:xfrm>
        </p:spPr>
        <p:txBody>
          <a:bodyPr anchor="b"/>
          <a:lstStyle>
            <a:lvl1pPr marL="0" indent="0">
              <a:buNone/>
              <a:defRPr sz="2145" b="1"/>
            </a:lvl1pPr>
            <a:lvl2pPr marL="408645" indent="0">
              <a:buNone/>
              <a:defRPr sz="1788" b="1"/>
            </a:lvl2pPr>
            <a:lvl3pPr marL="817291" indent="0">
              <a:buNone/>
              <a:defRPr sz="1609" b="1"/>
            </a:lvl3pPr>
            <a:lvl4pPr marL="1225936" indent="0">
              <a:buNone/>
              <a:defRPr sz="1430" b="1"/>
            </a:lvl4pPr>
            <a:lvl5pPr marL="1634581" indent="0">
              <a:buNone/>
              <a:defRPr sz="1430" b="1"/>
            </a:lvl5pPr>
            <a:lvl6pPr marL="2043227" indent="0">
              <a:buNone/>
              <a:defRPr sz="1430" b="1"/>
            </a:lvl6pPr>
            <a:lvl7pPr marL="2451872" indent="0">
              <a:buNone/>
              <a:defRPr sz="1430" b="1"/>
            </a:lvl7pPr>
            <a:lvl8pPr marL="2860518" indent="0">
              <a:buNone/>
              <a:defRPr sz="1430" b="1"/>
            </a:lvl8pPr>
            <a:lvl9pPr marL="3269163" indent="0">
              <a:buNone/>
              <a:defRPr sz="143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2921" y="2393159"/>
            <a:ext cx="3457329" cy="351997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37303" y="1606056"/>
            <a:ext cx="3474356" cy="787103"/>
          </a:xfrm>
        </p:spPr>
        <p:txBody>
          <a:bodyPr anchor="b"/>
          <a:lstStyle>
            <a:lvl1pPr marL="0" indent="0">
              <a:buNone/>
              <a:defRPr sz="2145" b="1"/>
            </a:lvl1pPr>
            <a:lvl2pPr marL="408645" indent="0">
              <a:buNone/>
              <a:defRPr sz="1788" b="1"/>
            </a:lvl2pPr>
            <a:lvl3pPr marL="817291" indent="0">
              <a:buNone/>
              <a:defRPr sz="1609" b="1"/>
            </a:lvl3pPr>
            <a:lvl4pPr marL="1225936" indent="0">
              <a:buNone/>
              <a:defRPr sz="1430" b="1"/>
            </a:lvl4pPr>
            <a:lvl5pPr marL="1634581" indent="0">
              <a:buNone/>
              <a:defRPr sz="1430" b="1"/>
            </a:lvl5pPr>
            <a:lvl6pPr marL="2043227" indent="0">
              <a:buNone/>
              <a:defRPr sz="1430" b="1"/>
            </a:lvl6pPr>
            <a:lvl7pPr marL="2451872" indent="0">
              <a:buNone/>
              <a:defRPr sz="1430" b="1"/>
            </a:lvl7pPr>
            <a:lvl8pPr marL="2860518" indent="0">
              <a:buNone/>
              <a:defRPr sz="1430" b="1"/>
            </a:lvl8pPr>
            <a:lvl9pPr marL="3269163" indent="0">
              <a:buNone/>
              <a:defRPr sz="143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37303" y="2393159"/>
            <a:ext cx="3474356" cy="351997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91752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8772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2973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2920" y="436774"/>
            <a:ext cx="2635828" cy="1528710"/>
          </a:xfrm>
        </p:spPr>
        <p:txBody>
          <a:bodyPr anchor="b"/>
          <a:lstStyle>
            <a:lvl1pPr>
              <a:defRPr sz="28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74356" y="943312"/>
            <a:ext cx="4137303" cy="4655892"/>
          </a:xfrm>
        </p:spPr>
        <p:txBody>
          <a:bodyPr/>
          <a:lstStyle>
            <a:lvl1pPr>
              <a:defRPr sz="2860"/>
            </a:lvl1pPr>
            <a:lvl2pPr>
              <a:defRPr sz="2503"/>
            </a:lvl2pPr>
            <a:lvl3pPr>
              <a:defRPr sz="2145"/>
            </a:lvl3pPr>
            <a:lvl4pPr>
              <a:defRPr sz="1788"/>
            </a:lvl4pPr>
            <a:lvl5pPr>
              <a:defRPr sz="1788"/>
            </a:lvl5pPr>
            <a:lvl6pPr>
              <a:defRPr sz="1788"/>
            </a:lvl6pPr>
            <a:lvl7pPr>
              <a:defRPr sz="1788"/>
            </a:lvl7pPr>
            <a:lvl8pPr>
              <a:defRPr sz="1788"/>
            </a:lvl8pPr>
            <a:lvl9pPr>
              <a:defRPr sz="1788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2920" y="1965484"/>
            <a:ext cx="2635828" cy="3641302"/>
          </a:xfrm>
        </p:spPr>
        <p:txBody>
          <a:bodyPr/>
          <a:lstStyle>
            <a:lvl1pPr marL="0" indent="0">
              <a:buNone/>
              <a:defRPr sz="1430"/>
            </a:lvl1pPr>
            <a:lvl2pPr marL="408645" indent="0">
              <a:buNone/>
              <a:defRPr sz="1251"/>
            </a:lvl2pPr>
            <a:lvl3pPr marL="817291" indent="0">
              <a:buNone/>
              <a:defRPr sz="1073"/>
            </a:lvl3pPr>
            <a:lvl4pPr marL="1225936" indent="0">
              <a:buNone/>
              <a:defRPr sz="894"/>
            </a:lvl4pPr>
            <a:lvl5pPr marL="1634581" indent="0">
              <a:buNone/>
              <a:defRPr sz="894"/>
            </a:lvl5pPr>
            <a:lvl6pPr marL="2043227" indent="0">
              <a:buNone/>
              <a:defRPr sz="894"/>
            </a:lvl6pPr>
            <a:lvl7pPr marL="2451872" indent="0">
              <a:buNone/>
              <a:defRPr sz="894"/>
            </a:lvl7pPr>
            <a:lvl8pPr marL="2860518" indent="0">
              <a:buNone/>
              <a:defRPr sz="894"/>
            </a:lvl8pPr>
            <a:lvl9pPr marL="3269163" indent="0">
              <a:buNone/>
              <a:defRPr sz="89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4521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2920" y="436774"/>
            <a:ext cx="2635828" cy="1528710"/>
          </a:xfrm>
        </p:spPr>
        <p:txBody>
          <a:bodyPr anchor="b"/>
          <a:lstStyle>
            <a:lvl1pPr>
              <a:defRPr sz="28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74356" y="943312"/>
            <a:ext cx="4137303" cy="4655892"/>
          </a:xfrm>
        </p:spPr>
        <p:txBody>
          <a:bodyPr anchor="t"/>
          <a:lstStyle>
            <a:lvl1pPr marL="0" indent="0">
              <a:buNone/>
              <a:defRPr sz="2860"/>
            </a:lvl1pPr>
            <a:lvl2pPr marL="408645" indent="0">
              <a:buNone/>
              <a:defRPr sz="2503"/>
            </a:lvl2pPr>
            <a:lvl3pPr marL="817291" indent="0">
              <a:buNone/>
              <a:defRPr sz="2145"/>
            </a:lvl3pPr>
            <a:lvl4pPr marL="1225936" indent="0">
              <a:buNone/>
              <a:defRPr sz="1788"/>
            </a:lvl4pPr>
            <a:lvl5pPr marL="1634581" indent="0">
              <a:buNone/>
              <a:defRPr sz="1788"/>
            </a:lvl5pPr>
            <a:lvl6pPr marL="2043227" indent="0">
              <a:buNone/>
              <a:defRPr sz="1788"/>
            </a:lvl6pPr>
            <a:lvl7pPr marL="2451872" indent="0">
              <a:buNone/>
              <a:defRPr sz="1788"/>
            </a:lvl7pPr>
            <a:lvl8pPr marL="2860518" indent="0">
              <a:buNone/>
              <a:defRPr sz="1788"/>
            </a:lvl8pPr>
            <a:lvl9pPr marL="3269163" indent="0">
              <a:buNone/>
              <a:defRPr sz="1788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2920" y="1965484"/>
            <a:ext cx="2635828" cy="3641302"/>
          </a:xfrm>
        </p:spPr>
        <p:txBody>
          <a:bodyPr/>
          <a:lstStyle>
            <a:lvl1pPr marL="0" indent="0">
              <a:buNone/>
              <a:defRPr sz="1430"/>
            </a:lvl1pPr>
            <a:lvl2pPr marL="408645" indent="0">
              <a:buNone/>
              <a:defRPr sz="1251"/>
            </a:lvl2pPr>
            <a:lvl3pPr marL="817291" indent="0">
              <a:buNone/>
              <a:defRPr sz="1073"/>
            </a:lvl3pPr>
            <a:lvl4pPr marL="1225936" indent="0">
              <a:buNone/>
              <a:defRPr sz="894"/>
            </a:lvl4pPr>
            <a:lvl5pPr marL="1634581" indent="0">
              <a:buNone/>
              <a:defRPr sz="894"/>
            </a:lvl5pPr>
            <a:lvl6pPr marL="2043227" indent="0">
              <a:buNone/>
              <a:defRPr sz="894"/>
            </a:lvl6pPr>
            <a:lvl7pPr marL="2451872" indent="0">
              <a:buNone/>
              <a:defRPr sz="894"/>
            </a:lvl7pPr>
            <a:lvl8pPr marL="2860518" indent="0">
              <a:buNone/>
              <a:defRPr sz="894"/>
            </a:lvl8pPr>
            <a:lvl9pPr marL="3269163" indent="0">
              <a:buNone/>
              <a:defRPr sz="89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6514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1856" y="348814"/>
            <a:ext cx="7048738" cy="12663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856" y="1744064"/>
            <a:ext cx="7048738" cy="4156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1856" y="6072376"/>
            <a:ext cx="1838801" cy="3488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73BC7-A508-4C97-82B1-CCC282A33129}" type="datetimeFigureOut">
              <a:rPr lang="en-CA" smtClean="0"/>
              <a:t>2015-11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07124" y="6072376"/>
            <a:ext cx="2758202" cy="3488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71793" y="6072376"/>
            <a:ext cx="1838801" cy="3488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02CA1-2F70-44D0-9D45-FCC3BE3D9A4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6523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7" r:id="rId1"/>
    <p:sldLayoutId id="2147483878" r:id="rId2"/>
    <p:sldLayoutId id="2147483879" r:id="rId3"/>
    <p:sldLayoutId id="2147483880" r:id="rId4"/>
    <p:sldLayoutId id="2147483881" r:id="rId5"/>
    <p:sldLayoutId id="2147483882" r:id="rId6"/>
    <p:sldLayoutId id="2147483883" r:id="rId7"/>
    <p:sldLayoutId id="2147483884" r:id="rId8"/>
    <p:sldLayoutId id="2147483885" r:id="rId9"/>
    <p:sldLayoutId id="2147483886" r:id="rId10"/>
    <p:sldLayoutId id="2147483887" r:id="rId11"/>
  </p:sldLayoutIdLst>
  <p:txStyles>
    <p:titleStyle>
      <a:lvl1pPr algn="l" defTabSz="817291" rtl="0" eaLnBrk="1" latinLnBrk="0" hangingPunct="1">
        <a:lnSpc>
          <a:spcPct val="90000"/>
        </a:lnSpc>
        <a:spcBef>
          <a:spcPct val="0"/>
        </a:spcBef>
        <a:buNone/>
        <a:defRPr sz="3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4323" indent="-204323" algn="l" defTabSz="817291" rtl="0" eaLnBrk="1" latinLnBrk="0" hangingPunct="1">
        <a:lnSpc>
          <a:spcPct val="90000"/>
        </a:lnSpc>
        <a:spcBef>
          <a:spcPts val="894"/>
        </a:spcBef>
        <a:buFont typeface="Arial" panose="020B0604020202020204" pitchFamily="34" charset="0"/>
        <a:buChar char="•"/>
        <a:defRPr sz="2503" kern="1200">
          <a:solidFill>
            <a:schemeClr val="tx1"/>
          </a:solidFill>
          <a:latin typeface="+mn-lt"/>
          <a:ea typeface="+mn-ea"/>
          <a:cs typeface="+mn-cs"/>
        </a:defRPr>
      </a:lvl1pPr>
      <a:lvl2pPr marL="612968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2145" kern="1200">
          <a:solidFill>
            <a:schemeClr val="tx1"/>
          </a:solidFill>
          <a:latin typeface="+mn-lt"/>
          <a:ea typeface="+mn-ea"/>
          <a:cs typeface="+mn-cs"/>
        </a:defRPr>
      </a:lvl2pPr>
      <a:lvl3pPr marL="1021613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788" kern="1200">
          <a:solidFill>
            <a:schemeClr val="tx1"/>
          </a:solidFill>
          <a:latin typeface="+mn-lt"/>
          <a:ea typeface="+mn-ea"/>
          <a:cs typeface="+mn-cs"/>
        </a:defRPr>
      </a:lvl3pPr>
      <a:lvl4pPr marL="1430259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9" kern="1200">
          <a:solidFill>
            <a:schemeClr val="tx1"/>
          </a:solidFill>
          <a:latin typeface="+mn-lt"/>
          <a:ea typeface="+mn-ea"/>
          <a:cs typeface="+mn-cs"/>
        </a:defRPr>
      </a:lvl4pPr>
      <a:lvl5pPr marL="1838904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9" kern="1200">
          <a:solidFill>
            <a:schemeClr val="tx1"/>
          </a:solidFill>
          <a:latin typeface="+mn-lt"/>
          <a:ea typeface="+mn-ea"/>
          <a:cs typeface="+mn-cs"/>
        </a:defRPr>
      </a:lvl5pPr>
      <a:lvl6pPr marL="2247549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9" kern="1200">
          <a:solidFill>
            <a:schemeClr val="tx1"/>
          </a:solidFill>
          <a:latin typeface="+mn-lt"/>
          <a:ea typeface="+mn-ea"/>
          <a:cs typeface="+mn-cs"/>
        </a:defRPr>
      </a:lvl6pPr>
      <a:lvl7pPr marL="2656195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9" kern="1200">
          <a:solidFill>
            <a:schemeClr val="tx1"/>
          </a:solidFill>
          <a:latin typeface="+mn-lt"/>
          <a:ea typeface="+mn-ea"/>
          <a:cs typeface="+mn-cs"/>
        </a:defRPr>
      </a:lvl7pPr>
      <a:lvl8pPr marL="3064840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9" kern="1200">
          <a:solidFill>
            <a:schemeClr val="tx1"/>
          </a:solidFill>
          <a:latin typeface="+mn-lt"/>
          <a:ea typeface="+mn-ea"/>
          <a:cs typeface="+mn-cs"/>
        </a:defRPr>
      </a:lvl8pPr>
      <a:lvl9pPr marL="3473486" indent="-204323" algn="l" defTabSz="817291" rtl="0" eaLnBrk="1" latinLnBrk="0" hangingPunct="1">
        <a:lnSpc>
          <a:spcPct val="90000"/>
        </a:lnSpc>
        <a:spcBef>
          <a:spcPts val="447"/>
        </a:spcBef>
        <a:buFont typeface="Arial" panose="020B0604020202020204" pitchFamily="34" charset="0"/>
        <a:buChar char="•"/>
        <a:defRPr sz="16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1pPr>
      <a:lvl2pPr marL="408645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2pPr>
      <a:lvl3pPr marL="817291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3pPr>
      <a:lvl4pPr marL="1225936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4pPr>
      <a:lvl5pPr marL="1634581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5pPr>
      <a:lvl6pPr marL="2043227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6pPr>
      <a:lvl7pPr marL="2451872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7pPr>
      <a:lvl8pPr marL="2860518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8pPr>
      <a:lvl9pPr marL="3269163" algn="l" defTabSz="817291" rtl="0" eaLnBrk="1" latinLnBrk="0" hangingPunct="1">
        <a:defRPr sz="16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TextBox 367"/>
          <p:cNvSpPr txBox="1"/>
          <p:nvPr/>
        </p:nvSpPr>
        <p:spPr>
          <a:xfrm>
            <a:off x="3258536" y="6145559"/>
            <a:ext cx="1401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9" name="Group 218"/>
          <p:cNvGrpSpPr>
            <a:grpSpLocks/>
          </p:cNvGrpSpPr>
          <p:nvPr/>
        </p:nvGrpSpPr>
        <p:grpSpPr bwMode="auto">
          <a:xfrm>
            <a:off x="216685" y="507822"/>
            <a:ext cx="4226035" cy="2528191"/>
            <a:chOff x="105143288" y="106383163"/>
            <a:chExt cx="5999607" cy="3588877"/>
          </a:xfrm>
        </p:grpSpPr>
        <p:pic>
          <p:nvPicPr>
            <p:cNvPr id="370" name="Picture 219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09"/>
            <a:stretch/>
          </p:blipFill>
          <p:spPr bwMode="auto">
            <a:xfrm>
              <a:off x="106709611" y="106734782"/>
              <a:ext cx="1203925" cy="32372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371" name="Picture 220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7922599" y="106734783"/>
              <a:ext cx="1255885" cy="3237257"/>
            </a:xfrm>
            <a:prstGeom prst="rect">
              <a:avLst/>
            </a:prstGeom>
            <a:noFill/>
            <a:ln w="6350" algn="ctr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cxnSp>
          <p:nvCxnSpPr>
            <p:cNvPr id="372" name="AutoShape 221"/>
            <p:cNvCxnSpPr>
              <a:cxnSpLocks noChangeShapeType="1"/>
            </p:cNvCxnSpPr>
            <p:nvPr/>
          </p:nvCxnSpPr>
          <p:spPr bwMode="auto">
            <a:xfrm>
              <a:off x="106138042" y="10780639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73" name="AutoShape 222"/>
            <p:cNvCxnSpPr>
              <a:cxnSpLocks noChangeShapeType="1"/>
            </p:cNvCxnSpPr>
            <p:nvPr/>
          </p:nvCxnSpPr>
          <p:spPr bwMode="auto">
            <a:xfrm>
              <a:off x="106138042" y="10802737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74" name="AutoShape 223"/>
            <p:cNvCxnSpPr>
              <a:cxnSpLocks noChangeShapeType="1"/>
            </p:cNvCxnSpPr>
            <p:nvPr/>
          </p:nvCxnSpPr>
          <p:spPr bwMode="auto">
            <a:xfrm>
              <a:off x="106145662" y="10822549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75" name="AutoShape 224"/>
            <p:cNvCxnSpPr>
              <a:cxnSpLocks noChangeShapeType="1"/>
            </p:cNvCxnSpPr>
            <p:nvPr/>
          </p:nvCxnSpPr>
          <p:spPr bwMode="auto">
            <a:xfrm>
              <a:off x="106145662" y="10830931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76" name="AutoShape 225"/>
            <p:cNvCxnSpPr>
              <a:cxnSpLocks noChangeShapeType="1"/>
            </p:cNvCxnSpPr>
            <p:nvPr/>
          </p:nvCxnSpPr>
          <p:spPr bwMode="auto">
            <a:xfrm flipH="1">
              <a:off x="109193662" y="10785211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377" name="Text Box 226"/>
            <p:cNvSpPr txBox="1">
              <a:spLocks noChangeArrowheads="1"/>
            </p:cNvSpPr>
            <p:nvPr/>
          </p:nvSpPr>
          <p:spPr bwMode="auto">
            <a:xfrm>
              <a:off x="105158528" y="107674380"/>
              <a:ext cx="982980" cy="220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5025 nt) 28S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78" name="Text Box 227"/>
            <p:cNvSpPr txBox="1">
              <a:spLocks noChangeArrowheads="1"/>
            </p:cNvSpPr>
            <p:nvPr/>
          </p:nvSpPr>
          <p:spPr bwMode="auto">
            <a:xfrm>
              <a:off x="105143288" y="107880120"/>
              <a:ext cx="99822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3012 nt) 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79" name="Text Box 228"/>
            <p:cNvSpPr txBox="1">
              <a:spLocks noChangeArrowheads="1"/>
            </p:cNvSpPr>
            <p:nvPr/>
          </p:nvSpPr>
          <p:spPr bwMode="auto">
            <a:xfrm>
              <a:off x="105143288" y="108085860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1868 nt) 18S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80" name="Text Box 229"/>
            <p:cNvSpPr txBox="1">
              <a:spLocks noChangeArrowheads="1"/>
            </p:cNvSpPr>
            <p:nvPr/>
          </p:nvSpPr>
          <p:spPr bwMode="auto">
            <a:xfrm>
              <a:off x="105143288" y="108246670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1630 nt) 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81" name="Text Box 230"/>
            <p:cNvSpPr txBox="1">
              <a:spLocks noChangeArrowheads="1"/>
            </p:cNvSpPr>
            <p:nvPr/>
          </p:nvSpPr>
          <p:spPr bwMode="auto">
            <a:xfrm>
              <a:off x="109670058" y="107614040"/>
              <a:ext cx="1472837" cy="7156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(5025 nt) </a:t>
              </a:r>
            </a:p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28S-1 probe</a:t>
              </a:r>
              <a:endParaRPr lang="en-US" altLang="en-US" sz="1268" dirty="0">
                <a:latin typeface="Arial" panose="020B0604020202020204" pitchFamily="34" charset="0"/>
              </a:endParaRPr>
            </a:p>
          </p:txBody>
        </p:sp>
        <p:sp>
          <p:nvSpPr>
            <p:cNvPr id="382" name="Text Box 231"/>
            <p:cNvSpPr txBox="1">
              <a:spLocks noChangeArrowheads="1"/>
            </p:cNvSpPr>
            <p:nvPr/>
          </p:nvSpPr>
          <p:spPr bwMode="auto">
            <a:xfrm>
              <a:off x="107041156" y="106383163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268" dirty="0">
                <a:latin typeface="Arial" panose="020B0604020202020204" pitchFamily="34" charset="0"/>
              </a:endParaRPr>
            </a:p>
          </p:txBody>
        </p:sp>
        <p:sp>
          <p:nvSpPr>
            <p:cNvPr id="383" name="Text Box 232"/>
            <p:cNvSpPr txBox="1">
              <a:spLocks noChangeArrowheads="1"/>
            </p:cNvSpPr>
            <p:nvPr/>
          </p:nvSpPr>
          <p:spPr bwMode="auto">
            <a:xfrm>
              <a:off x="107587068" y="106412941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84" name="Text Box 233"/>
            <p:cNvSpPr txBox="1">
              <a:spLocks noChangeArrowheads="1"/>
            </p:cNvSpPr>
            <p:nvPr/>
          </p:nvSpPr>
          <p:spPr bwMode="auto">
            <a:xfrm>
              <a:off x="108367787" y="106384449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268" dirty="0">
                <a:latin typeface="Arial" panose="020B0604020202020204" pitchFamily="34" charset="0"/>
              </a:endParaRPr>
            </a:p>
          </p:txBody>
        </p:sp>
        <p:sp>
          <p:nvSpPr>
            <p:cNvPr id="385" name="Text Box 234"/>
            <p:cNvSpPr txBox="1">
              <a:spLocks noChangeArrowheads="1"/>
            </p:cNvSpPr>
            <p:nvPr/>
          </p:nvSpPr>
          <p:spPr bwMode="auto">
            <a:xfrm>
              <a:off x="108862330" y="106414227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</p:grpSp>
      <p:grpSp>
        <p:nvGrpSpPr>
          <p:cNvPr id="386" name="Group 235"/>
          <p:cNvGrpSpPr>
            <a:grpSpLocks/>
          </p:cNvGrpSpPr>
          <p:nvPr/>
        </p:nvGrpSpPr>
        <p:grpSpPr bwMode="auto">
          <a:xfrm>
            <a:off x="4159190" y="507842"/>
            <a:ext cx="3902844" cy="2544966"/>
            <a:chOff x="110286348" y="106230751"/>
            <a:chExt cx="5539519" cy="3613461"/>
          </a:xfrm>
        </p:grpSpPr>
        <p:pic>
          <p:nvPicPr>
            <p:cNvPr id="387" name="Picture 236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5" r="12618"/>
            <a:stretch/>
          </p:blipFill>
          <p:spPr bwMode="auto">
            <a:xfrm>
              <a:off x="112819006" y="106596751"/>
              <a:ext cx="962979" cy="3239818"/>
            </a:xfrm>
            <a:prstGeom prst="rect">
              <a:avLst/>
            </a:prstGeom>
            <a:noFill/>
            <a:ln w="6350" algn="ctr">
              <a:solidFill>
                <a:srgbClr val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388" name="Picture 237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790306" y="106604315"/>
              <a:ext cx="1033560" cy="32398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sp>
          <p:nvSpPr>
            <p:cNvPr id="389" name="Text Box 238"/>
            <p:cNvSpPr txBox="1">
              <a:spLocks noChangeArrowheads="1"/>
            </p:cNvSpPr>
            <p:nvPr/>
          </p:nvSpPr>
          <p:spPr bwMode="auto">
            <a:xfrm>
              <a:off x="110301588" y="107552205"/>
              <a:ext cx="982980" cy="2209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5025 nt) 28S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90" name="Text Box 239"/>
            <p:cNvSpPr txBox="1">
              <a:spLocks noChangeArrowheads="1"/>
            </p:cNvSpPr>
            <p:nvPr/>
          </p:nvSpPr>
          <p:spPr bwMode="auto">
            <a:xfrm>
              <a:off x="110286348" y="107757945"/>
              <a:ext cx="99822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3012 nt) 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91" name="Text Box 240"/>
            <p:cNvSpPr txBox="1">
              <a:spLocks noChangeArrowheads="1"/>
            </p:cNvSpPr>
            <p:nvPr/>
          </p:nvSpPr>
          <p:spPr bwMode="auto">
            <a:xfrm>
              <a:off x="110286348" y="107963281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1868 nt) 18S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92" name="Text Box 241"/>
            <p:cNvSpPr txBox="1">
              <a:spLocks noChangeArrowheads="1"/>
            </p:cNvSpPr>
            <p:nvPr/>
          </p:nvSpPr>
          <p:spPr bwMode="auto">
            <a:xfrm>
              <a:off x="110286348" y="108115277"/>
              <a:ext cx="998220" cy="2438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algn="r"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1630 nt) 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cxnSp>
          <p:nvCxnSpPr>
            <p:cNvPr id="393" name="AutoShape 242"/>
            <p:cNvCxnSpPr>
              <a:cxnSpLocks noChangeShapeType="1"/>
            </p:cNvCxnSpPr>
            <p:nvPr/>
          </p:nvCxnSpPr>
          <p:spPr bwMode="auto">
            <a:xfrm>
              <a:off x="111279351" y="10768976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94" name="AutoShape 243"/>
            <p:cNvCxnSpPr>
              <a:cxnSpLocks noChangeShapeType="1"/>
            </p:cNvCxnSpPr>
            <p:nvPr/>
          </p:nvCxnSpPr>
          <p:spPr bwMode="auto">
            <a:xfrm>
              <a:off x="111286971" y="10788788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95" name="AutoShape 244"/>
            <p:cNvCxnSpPr>
              <a:cxnSpLocks noChangeShapeType="1"/>
            </p:cNvCxnSpPr>
            <p:nvPr/>
          </p:nvCxnSpPr>
          <p:spPr bwMode="auto">
            <a:xfrm>
              <a:off x="111294591" y="10812410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96" name="AutoShape 245"/>
            <p:cNvCxnSpPr>
              <a:cxnSpLocks noChangeShapeType="1"/>
            </p:cNvCxnSpPr>
            <p:nvPr/>
          </p:nvCxnSpPr>
          <p:spPr bwMode="auto">
            <a:xfrm>
              <a:off x="111294591" y="10819268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97" name="AutoShape 246"/>
            <p:cNvCxnSpPr>
              <a:cxnSpLocks noChangeShapeType="1"/>
            </p:cNvCxnSpPr>
            <p:nvPr/>
          </p:nvCxnSpPr>
          <p:spPr bwMode="auto">
            <a:xfrm flipH="1">
              <a:off x="113885391" y="107750722"/>
              <a:ext cx="464820" cy="0"/>
            </a:xfrm>
            <a:prstGeom prst="straightConnector1">
              <a:avLst/>
            </a:prstGeom>
            <a:noFill/>
            <a:ln w="25400" algn="ctr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398" name="Text Box 247"/>
            <p:cNvSpPr txBox="1">
              <a:spLocks noChangeArrowheads="1"/>
            </p:cNvSpPr>
            <p:nvPr/>
          </p:nvSpPr>
          <p:spPr bwMode="auto">
            <a:xfrm>
              <a:off x="114353030" y="107499697"/>
              <a:ext cx="1472837" cy="5646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(5025 nt) </a:t>
              </a:r>
            </a:p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CA" altLang="en-US" sz="845">
                  <a:solidFill>
                    <a:srgbClr val="000000"/>
                  </a:solidFill>
                  <a:latin typeface="Times New Roman" panose="02020603050405020304" pitchFamily="18" charset="0"/>
                </a:rPr>
                <a:t>28S-4 probe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399" name="Text Box 248"/>
            <p:cNvSpPr txBox="1">
              <a:spLocks noChangeArrowheads="1"/>
            </p:cNvSpPr>
            <p:nvPr/>
          </p:nvSpPr>
          <p:spPr bwMode="auto">
            <a:xfrm>
              <a:off x="112064217" y="106230751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268" dirty="0">
                <a:latin typeface="Arial" panose="020B0604020202020204" pitchFamily="34" charset="0"/>
              </a:endParaRPr>
            </a:p>
          </p:txBody>
        </p:sp>
        <p:sp>
          <p:nvSpPr>
            <p:cNvPr id="400" name="Text Box 249"/>
            <p:cNvSpPr txBox="1">
              <a:spLocks noChangeArrowheads="1"/>
            </p:cNvSpPr>
            <p:nvPr/>
          </p:nvSpPr>
          <p:spPr bwMode="auto">
            <a:xfrm>
              <a:off x="112301909" y="106260536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  <p:sp>
          <p:nvSpPr>
            <p:cNvPr id="401" name="Text Box 250"/>
            <p:cNvSpPr txBox="1">
              <a:spLocks noChangeArrowheads="1"/>
            </p:cNvSpPr>
            <p:nvPr/>
          </p:nvSpPr>
          <p:spPr bwMode="auto">
            <a:xfrm>
              <a:off x="113010711" y="106238048"/>
              <a:ext cx="186780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–</a:t>
              </a:r>
              <a:endParaRPr lang="en-US" altLang="en-US" sz="1268" dirty="0">
                <a:latin typeface="Arial" panose="020B0604020202020204" pitchFamily="34" charset="0"/>
              </a:endParaRPr>
            </a:p>
          </p:txBody>
        </p:sp>
        <p:sp>
          <p:nvSpPr>
            <p:cNvPr id="402" name="Text Box 251"/>
            <p:cNvSpPr txBox="1">
              <a:spLocks noChangeArrowheads="1"/>
            </p:cNvSpPr>
            <p:nvPr/>
          </p:nvSpPr>
          <p:spPr bwMode="auto">
            <a:xfrm>
              <a:off x="113238129" y="106261822"/>
              <a:ext cx="248773" cy="3362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5B9BD5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25766" tIns="25766" rIns="25766" bIns="25766" numCol="1" anchor="t" anchorCtr="0" compatLnSpc="1">
              <a:prstTxWarp prst="textNoShape">
                <a:avLst/>
              </a:prstTxWarp>
            </a:bodyPr>
            <a:lstStyle/>
            <a:p>
              <a:pPr defTabSz="644083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68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+</a:t>
              </a:r>
              <a:endParaRPr lang="en-US" altLang="en-US" sz="1268">
                <a:latin typeface="Arial" panose="020B0604020202020204" pitchFamily="34" charset="0"/>
              </a:endParaRPr>
            </a:p>
          </p:txBody>
        </p:sp>
      </p:grpSp>
      <p:sp>
        <p:nvSpPr>
          <p:cNvPr id="437" name="Text Box 286"/>
          <p:cNvSpPr txBox="1">
            <a:spLocks noChangeArrowheads="1"/>
          </p:cNvSpPr>
          <p:nvPr/>
        </p:nvSpPr>
        <p:spPr bwMode="auto">
          <a:xfrm>
            <a:off x="216692" y="70505"/>
            <a:ext cx="204648" cy="1945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25766" tIns="25766" rIns="25766" bIns="25766" numCol="1" anchor="t" anchorCtr="0" compatLnSpc="1">
            <a:prstTxWarp prst="textNoShape">
              <a:avLst/>
            </a:prstTxWarp>
          </a:bodyPr>
          <a:lstStyle/>
          <a:p>
            <a:pPr defTabSz="6440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845">
                <a:solidFill>
                  <a:srgbClr val="000000"/>
                </a:solidFill>
                <a:latin typeface="Times New Roman" panose="02020603050405020304" pitchFamily="18" charset="0"/>
              </a:rPr>
              <a:t>A.</a:t>
            </a:r>
            <a:endParaRPr lang="en-US" altLang="en-US" sz="1268">
              <a:latin typeface="Arial" panose="020B0604020202020204" pitchFamily="34" charset="0"/>
            </a:endParaRPr>
          </a:p>
        </p:txBody>
      </p:sp>
      <p:sp>
        <p:nvSpPr>
          <p:cNvPr id="438" name="Text Box 287"/>
          <p:cNvSpPr txBox="1">
            <a:spLocks noChangeArrowheads="1"/>
          </p:cNvSpPr>
          <p:nvPr/>
        </p:nvSpPr>
        <p:spPr bwMode="auto">
          <a:xfrm>
            <a:off x="4137718" y="70505"/>
            <a:ext cx="204648" cy="1945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25766" tIns="25766" rIns="25766" bIns="25766" numCol="1" anchor="t" anchorCtr="0" compatLnSpc="1">
            <a:prstTxWarp prst="textNoShape">
              <a:avLst/>
            </a:prstTxWarp>
          </a:bodyPr>
          <a:lstStyle/>
          <a:p>
            <a:pPr defTabSz="6440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845">
                <a:solidFill>
                  <a:srgbClr val="000000"/>
                </a:solidFill>
                <a:latin typeface="Times New Roman" panose="02020603050405020304" pitchFamily="18" charset="0"/>
              </a:rPr>
              <a:t>B.</a:t>
            </a:r>
            <a:endParaRPr lang="en-US" altLang="en-US" sz="1268">
              <a:latin typeface="Arial" panose="020B0604020202020204" pitchFamily="34" charset="0"/>
            </a:endParaRPr>
          </a:p>
        </p:txBody>
      </p:sp>
      <p:sp>
        <p:nvSpPr>
          <p:cNvPr id="439" name="Text Box 288"/>
          <p:cNvSpPr txBox="1">
            <a:spLocks noChangeArrowheads="1"/>
          </p:cNvSpPr>
          <p:nvPr/>
        </p:nvSpPr>
        <p:spPr bwMode="auto">
          <a:xfrm>
            <a:off x="216692" y="3254085"/>
            <a:ext cx="204648" cy="1945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25766" tIns="25766" rIns="25766" bIns="25766" numCol="1" anchor="t" anchorCtr="0" compatLnSpc="1">
            <a:prstTxWarp prst="textNoShape">
              <a:avLst/>
            </a:prstTxWarp>
          </a:bodyPr>
          <a:lstStyle/>
          <a:p>
            <a:pPr defTabSz="6440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845">
                <a:solidFill>
                  <a:srgbClr val="000000"/>
                </a:solidFill>
                <a:latin typeface="Times New Roman" panose="02020603050405020304" pitchFamily="18" charset="0"/>
              </a:rPr>
              <a:t>C.</a:t>
            </a:r>
            <a:endParaRPr lang="en-US" altLang="en-US" sz="1268">
              <a:latin typeface="Arial" panose="020B0604020202020204" pitchFamily="34" charset="0"/>
            </a:endParaRPr>
          </a:p>
        </p:txBody>
      </p:sp>
      <p:sp>
        <p:nvSpPr>
          <p:cNvPr id="440" name="Text Box 289"/>
          <p:cNvSpPr txBox="1">
            <a:spLocks noChangeArrowheads="1"/>
          </p:cNvSpPr>
          <p:nvPr/>
        </p:nvSpPr>
        <p:spPr bwMode="auto">
          <a:xfrm>
            <a:off x="4137718" y="3254085"/>
            <a:ext cx="204648" cy="1945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5B9BD5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25766" tIns="25766" rIns="25766" bIns="25766" numCol="1" anchor="t" anchorCtr="0" compatLnSpc="1">
            <a:prstTxWarp prst="textNoShape">
              <a:avLst/>
            </a:prstTxWarp>
          </a:bodyPr>
          <a:lstStyle/>
          <a:p>
            <a:pPr defTabSz="644083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845">
                <a:solidFill>
                  <a:srgbClr val="000000"/>
                </a:solidFill>
                <a:latin typeface="Times New Roman" panose="02020603050405020304" pitchFamily="18" charset="0"/>
              </a:rPr>
              <a:t>D.</a:t>
            </a:r>
            <a:endParaRPr lang="en-US" altLang="en-US" sz="1268">
              <a:latin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020517" y="512228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2466530" y="3252851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6185003" y="3278880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6587430" y="527073"/>
            <a:ext cx="886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ocetaxel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16692" y="3274185"/>
            <a:ext cx="3855875" cy="2527345"/>
            <a:chOff x="216692" y="3274185"/>
            <a:chExt cx="3855875" cy="2527345"/>
          </a:xfrm>
        </p:grpSpPr>
        <p:grpSp>
          <p:nvGrpSpPr>
            <p:cNvPr id="403" name="Group 252"/>
            <p:cNvGrpSpPr>
              <a:grpSpLocks/>
            </p:cNvGrpSpPr>
            <p:nvPr/>
          </p:nvGrpSpPr>
          <p:grpSpPr bwMode="auto">
            <a:xfrm>
              <a:off x="216692" y="3274185"/>
              <a:ext cx="3855875" cy="2527345"/>
              <a:chOff x="105143288" y="110310171"/>
              <a:chExt cx="5473302" cy="3588179"/>
            </a:xfrm>
          </p:grpSpPr>
          <p:pic>
            <p:nvPicPr>
              <p:cNvPr id="405" name="Picture 254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22" t="16065" b="11536"/>
              <a:stretch/>
            </p:blipFill>
            <p:spPr bwMode="auto">
              <a:xfrm>
                <a:off x="107514689" y="110770753"/>
                <a:ext cx="866790" cy="3127597"/>
              </a:xfrm>
              <a:prstGeom prst="rect">
                <a:avLst/>
              </a:prstGeom>
              <a:noFill/>
              <a:ln w="6350" algn="ctr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pic>
          <p:sp>
            <p:nvSpPr>
              <p:cNvPr id="406" name="Text Box 255"/>
              <p:cNvSpPr txBox="1">
                <a:spLocks noChangeArrowheads="1"/>
              </p:cNvSpPr>
              <p:nvPr/>
            </p:nvSpPr>
            <p:spPr bwMode="auto">
              <a:xfrm>
                <a:off x="105158528" y="111894187"/>
                <a:ext cx="982980" cy="22098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5025 nt) 28S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07" name="Text Box 256"/>
              <p:cNvSpPr txBox="1">
                <a:spLocks noChangeArrowheads="1"/>
              </p:cNvSpPr>
              <p:nvPr/>
            </p:nvSpPr>
            <p:spPr bwMode="auto">
              <a:xfrm>
                <a:off x="105143288" y="112124311"/>
                <a:ext cx="998220" cy="228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3012 nt) 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08" name="Text Box 257"/>
              <p:cNvSpPr txBox="1">
                <a:spLocks noChangeArrowheads="1"/>
              </p:cNvSpPr>
              <p:nvPr/>
            </p:nvSpPr>
            <p:spPr bwMode="auto">
              <a:xfrm>
                <a:off x="105143288" y="112379037"/>
                <a:ext cx="998220" cy="243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868 nt) 18S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09" name="Text Box 258"/>
              <p:cNvSpPr txBox="1">
                <a:spLocks noChangeArrowheads="1"/>
              </p:cNvSpPr>
              <p:nvPr/>
            </p:nvSpPr>
            <p:spPr bwMode="auto">
              <a:xfrm>
                <a:off x="105143288" y="112540363"/>
                <a:ext cx="998220" cy="243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630 nt) 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cxnSp>
            <p:nvCxnSpPr>
              <p:cNvPr id="410" name="AutoShape 259"/>
              <p:cNvCxnSpPr>
                <a:cxnSpLocks noChangeShapeType="1"/>
              </p:cNvCxnSpPr>
              <p:nvPr/>
            </p:nvCxnSpPr>
            <p:spPr bwMode="auto">
              <a:xfrm>
                <a:off x="106162893" y="112023727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11" name="AutoShape 260"/>
              <p:cNvCxnSpPr>
                <a:cxnSpLocks noChangeShapeType="1"/>
              </p:cNvCxnSpPr>
              <p:nvPr/>
            </p:nvCxnSpPr>
            <p:spPr bwMode="auto">
              <a:xfrm>
                <a:off x="106178133" y="112259947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12" name="AutoShape 261"/>
              <p:cNvCxnSpPr>
                <a:cxnSpLocks noChangeShapeType="1"/>
              </p:cNvCxnSpPr>
              <p:nvPr/>
            </p:nvCxnSpPr>
            <p:spPr bwMode="auto">
              <a:xfrm>
                <a:off x="106170513" y="112534267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13" name="AutoShape 262"/>
              <p:cNvCxnSpPr>
                <a:cxnSpLocks noChangeShapeType="1"/>
              </p:cNvCxnSpPr>
              <p:nvPr/>
            </p:nvCxnSpPr>
            <p:spPr bwMode="auto">
              <a:xfrm>
                <a:off x="106178133" y="112618087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14" name="AutoShape 263"/>
              <p:cNvCxnSpPr>
                <a:cxnSpLocks noChangeShapeType="1"/>
              </p:cNvCxnSpPr>
              <p:nvPr/>
            </p:nvCxnSpPr>
            <p:spPr bwMode="auto">
              <a:xfrm flipH="1">
                <a:off x="108418413" y="112023727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sp>
            <p:nvSpPr>
              <p:cNvPr id="415" name="Text Box 264"/>
              <p:cNvSpPr txBox="1">
                <a:spLocks noChangeArrowheads="1"/>
              </p:cNvSpPr>
              <p:nvPr/>
            </p:nvSpPr>
            <p:spPr bwMode="auto">
              <a:xfrm>
                <a:off x="108926039" y="111768408"/>
                <a:ext cx="1690551" cy="6107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5025 nt) </a:t>
                </a:r>
              </a:p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28S CD1 probe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16" name="Text Box 265"/>
              <p:cNvSpPr txBox="1">
                <a:spLocks noChangeArrowheads="1"/>
              </p:cNvSpPr>
              <p:nvPr/>
            </p:nvSpPr>
            <p:spPr bwMode="auto">
              <a:xfrm>
                <a:off x="106906222" y="110310171"/>
                <a:ext cx="186780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–</a:t>
                </a:r>
                <a:endParaRPr lang="en-US" altLang="en-US" sz="1268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17" name="Text Box 266"/>
              <p:cNvSpPr txBox="1">
                <a:spLocks noChangeArrowheads="1"/>
              </p:cNvSpPr>
              <p:nvPr/>
            </p:nvSpPr>
            <p:spPr bwMode="auto">
              <a:xfrm>
                <a:off x="107154188" y="110333945"/>
                <a:ext cx="248774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+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18" name="Text Box 267"/>
              <p:cNvSpPr txBox="1">
                <a:spLocks noChangeArrowheads="1"/>
              </p:cNvSpPr>
              <p:nvPr/>
            </p:nvSpPr>
            <p:spPr bwMode="auto">
              <a:xfrm>
                <a:off x="107780800" y="110317467"/>
                <a:ext cx="186780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–</a:t>
                </a:r>
                <a:endParaRPr lang="en-US" altLang="en-US" sz="1268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19" name="Text Box 268"/>
              <p:cNvSpPr txBox="1">
                <a:spLocks noChangeArrowheads="1"/>
              </p:cNvSpPr>
              <p:nvPr/>
            </p:nvSpPr>
            <p:spPr bwMode="auto">
              <a:xfrm>
                <a:off x="107977395" y="110335231"/>
                <a:ext cx="248774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+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</p:grp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21215" y="3596798"/>
              <a:ext cx="447675" cy="2200275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4148455" y="3277919"/>
            <a:ext cx="3671358" cy="2538286"/>
            <a:chOff x="4148455" y="3277919"/>
            <a:chExt cx="3671358" cy="2538286"/>
          </a:xfrm>
        </p:grpSpPr>
        <p:grpSp>
          <p:nvGrpSpPr>
            <p:cNvPr id="420" name="Group 269"/>
            <p:cNvGrpSpPr>
              <a:grpSpLocks/>
            </p:cNvGrpSpPr>
            <p:nvPr/>
          </p:nvGrpSpPr>
          <p:grpSpPr bwMode="auto">
            <a:xfrm>
              <a:off x="4148455" y="3277919"/>
              <a:ext cx="3671358" cy="2538286"/>
              <a:chOff x="110296622" y="110315910"/>
              <a:chExt cx="5212056" cy="3603548"/>
            </a:xfrm>
          </p:grpSpPr>
          <p:pic>
            <p:nvPicPr>
              <p:cNvPr id="421" name="Picture 270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43" t="5324" r="5643" b="-2821"/>
              <a:stretch/>
            </p:blipFill>
            <p:spPr bwMode="auto">
              <a:xfrm>
                <a:off x="112507766" y="110760578"/>
                <a:ext cx="698208" cy="3158880"/>
              </a:xfrm>
              <a:prstGeom prst="rect">
                <a:avLst/>
              </a:prstGeom>
              <a:noFill/>
              <a:ln w="6350" algn="ctr">
                <a:solidFill>
                  <a:srgbClr val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pic>
          <p:sp>
            <p:nvSpPr>
              <p:cNvPr id="423" name="Text Box 272"/>
              <p:cNvSpPr txBox="1">
                <a:spLocks noChangeArrowheads="1"/>
              </p:cNvSpPr>
              <p:nvPr/>
            </p:nvSpPr>
            <p:spPr bwMode="auto">
              <a:xfrm>
                <a:off x="110311862" y="111930678"/>
                <a:ext cx="982980" cy="22098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5025 nt) 28S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24" name="Text Box 273"/>
              <p:cNvSpPr txBox="1">
                <a:spLocks noChangeArrowheads="1"/>
              </p:cNvSpPr>
              <p:nvPr/>
            </p:nvSpPr>
            <p:spPr bwMode="auto">
              <a:xfrm>
                <a:off x="110296622" y="112204998"/>
                <a:ext cx="998220" cy="2286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3012 nt) 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25" name="Text Box 274"/>
              <p:cNvSpPr txBox="1">
                <a:spLocks noChangeArrowheads="1"/>
              </p:cNvSpPr>
              <p:nvPr/>
            </p:nvSpPr>
            <p:spPr bwMode="auto">
              <a:xfrm>
                <a:off x="110296622" y="112421406"/>
                <a:ext cx="998220" cy="243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868 nt) 18S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sp>
            <p:nvSpPr>
              <p:cNvPr id="426" name="Text Box 275"/>
              <p:cNvSpPr txBox="1">
                <a:spLocks noChangeArrowheads="1"/>
              </p:cNvSpPr>
              <p:nvPr/>
            </p:nvSpPr>
            <p:spPr bwMode="auto">
              <a:xfrm>
                <a:off x="110296622" y="112569234"/>
                <a:ext cx="998220" cy="243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algn="r"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1630 nt) 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  <p:cxnSp>
            <p:nvCxnSpPr>
              <p:cNvPr id="427" name="AutoShape 276"/>
              <p:cNvCxnSpPr>
                <a:cxnSpLocks noChangeShapeType="1"/>
              </p:cNvCxnSpPr>
              <p:nvPr/>
            </p:nvCxnSpPr>
            <p:spPr bwMode="auto">
              <a:xfrm>
                <a:off x="111290270" y="112063266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28" name="AutoShape 277"/>
              <p:cNvCxnSpPr>
                <a:cxnSpLocks noChangeShapeType="1"/>
              </p:cNvCxnSpPr>
              <p:nvPr/>
            </p:nvCxnSpPr>
            <p:spPr bwMode="auto">
              <a:xfrm>
                <a:off x="111297890" y="112329966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29" name="AutoShape 278"/>
              <p:cNvCxnSpPr>
                <a:cxnSpLocks noChangeShapeType="1"/>
              </p:cNvCxnSpPr>
              <p:nvPr/>
            </p:nvCxnSpPr>
            <p:spPr bwMode="auto">
              <a:xfrm>
                <a:off x="111305510" y="112550946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30" name="AutoShape 279"/>
              <p:cNvCxnSpPr>
                <a:cxnSpLocks noChangeShapeType="1"/>
              </p:cNvCxnSpPr>
              <p:nvPr/>
            </p:nvCxnSpPr>
            <p:spPr bwMode="auto">
              <a:xfrm>
                <a:off x="111307034" y="112634766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cxnSp>
            <p:nvCxnSpPr>
              <p:cNvPr id="431" name="AutoShape 280"/>
              <p:cNvCxnSpPr>
                <a:cxnSpLocks noChangeShapeType="1"/>
              </p:cNvCxnSpPr>
              <p:nvPr/>
            </p:nvCxnSpPr>
            <p:spPr bwMode="auto">
              <a:xfrm flipH="1">
                <a:off x="113240990" y="112093746"/>
                <a:ext cx="464820" cy="0"/>
              </a:xfrm>
              <a:prstGeom prst="straightConnector1">
                <a:avLst/>
              </a:prstGeom>
              <a:noFill/>
              <a:ln w="25400" algn="ctr">
                <a:solidFill>
                  <a:srgbClr val="00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</p:cxnSp>
          <p:sp>
            <p:nvSpPr>
              <p:cNvPr id="432" name="Text Box 281"/>
              <p:cNvSpPr txBox="1">
                <a:spLocks noChangeArrowheads="1"/>
              </p:cNvSpPr>
              <p:nvPr/>
            </p:nvSpPr>
            <p:spPr bwMode="auto">
              <a:xfrm>
                <a:off x="113731041" y="111835807"/>
                <a:ext cx="1777637" cy="5948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(5025 nt) </a:t>
                </a:r>
              </a:p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CA" altLang="en-US" sz="845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28S VR2 probe</a:t>
                </a:r>
                <a:endParaRPr lang="en-US" altLang="en-US" sz="1268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33" name="Text Box 282"/>
              <p:cNvSpPr txBox="1">
                <a:spLocks noChangeArrowheads="1"/>
              </p:cNvSpPr>
              <p:nvPr/>
            </p:nvSpPr>
            <p:spPr bwMode="auto">
              <a:xfrm>
                <a:off x="112035827" y="110329162"/>
                <a:ext cx="186780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–</a:t>
                </a:r>
                <a:endParaRPr lang="en-US" altLang="en-US" sz="1268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34" name="Text Box 283"/>
              <p:cNvSpPr txBox="1">
                <a:spLocks noChangeArrowheads="1"/>
              </p:cNvSpPr>
              <p:nvPr/>
            </p:nvSpPr>
            <p:spPr bwMode="auto">
              <a:xfrm>
                <a:off x="112273907" y="110357200"/>
                <a:ext cx="248773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+</a:t>
                </a:r>
                <a:endParaRPr lang="en-US" altLang="en-US" sz="1268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35" name="Text Box 284"/>
              <p:cNvSpPr txBox="1">
                <a:spLocks noChangeArrowheads="1"/>
              </p:cNvSpPr>
              <p:nvPr/>
            </p:nvSpPr>
            <p:spPr bwMode="auto">
              <a:xfrm>
                <a:off x="112685735" y="110315910"/>
                <a:ext cx="186780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 dirty="0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–</a:t>
                </a:r>
                <a:endParaRPr lang="en-US" altLang="en-US" sz="1268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436" name="Text Box 285"/>
              <p:cNvSpPr txBox="1">
                <a:spLocks noChangeArrowheads="1"/>
              </p:cNvSpPr>
              <p:nvPr/>
            </p:nvSpPr>
            <p:spPr bwMode="auto">
              <a:xfrm>
                <a:off x="112841236" y="110337939"/>
                <a:ext cx="248773" cy="33621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5B9BD5"/>
                    </a:solidFill>
                  </a14:hiddenFill>
                </a:ext>
                <a:ext uri="{91240B29-F687-4F45-9708-019B960494DF}">
                  <a14:hiddenLine xmlns:a14="http://schemas.microsoft.com/office/drawing/2010/main" w="25400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000000"/>
                      </a:outerShdw>
                    </a:effectLst>
                  </a14:hiddenEffects>
                </a:ext>
              </a:extLst>
            </p:spPr>
            <p:txBody>
              <a:bodyPr vert="horz" wrap="square" lIns="25766" tIns="25766" rIns="25766" bIns="25766" numCol="1" anchor="t" anchorCtr="0" compatLnSpc="1">
                <a:prstTxWarp prst="textNoShape">
                  <a:avLst/>
                </a:prstTxWarp>
              </a:bodyPr>
              <a:lstStyle/>
              <a:p>
                <a:pPr defTabSz="644083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1268" b="1">
                    <a:solidFill>
                      <a:srgbClr val="000000"/>
                    </a:solidFill>
                    <a:latin typeface="Times New Roman" panose="02020603050405020304" pitchFamily="18" charset="0"/>
                  </a:rPr>
                  <a:t>+</a:t>
                </a:r>
                <a:endParaRPr lang="en-US" altLang="en-US" sz="1268">
                  <a:latin typeface="Arial" panose="020B0604020202020204" pitchFamily="34" charset="0"/>
                </a:endParaRPr>
              </a:p>
            </p:txBody>
          </p:sp>
        </p:grp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284572" y="3587272"/>
              <a:ext cx="409575" cy="221932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40942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</TotalTime>
  <Words>129</Words>
  <Application>Microsoft Office PowerPoint</Application>
  <PresentationFormat>Custom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ya</dc:creator>
  <cp:lastModifiedBy>BQ guo</cp:lastModifiedBy>
  <cp:revision>10</cp:revision>
  <dcterms:created xsi:type="dcterms:W3CDTF">2015-04-09T16:56:14Z</dcterms:created>
  <dcterms:modified xsi:type="dcterms:W3CDTF">2015-11-15T17:58:24Z</dcterms:modified>
</cp:coreProperties>
</file>